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37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9311115903699245E-2"/>
          <c:y val="3.2128267095458705E-2"/>
          <c:w val="0.91163006808727742"/>
          <c:h val="0.94562908645383914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4"/>
            <c:marker>
              <c:symbol val="circle"/>
              <c:size val="5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72E0-44A4-810F-34FFC074F9CF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72E0-44A4-810F-34FFC074F9CF}"/>
              </c:ext>
            </c:extLst>
          </c:dPt>
          <c:dPt>
            <c:idx val="11"/>
            <c:marker>
              <c:symbol val="circle"/>
              <c:size val="5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72E0-44A4-810F-34FFC074F9CF}"/>
              </c:ext>
            </c:extLst>
          </c:dPt>
          <c:dPt>
            <c:idx val="1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72E0-44A4-810F-34FFC074F9CF}"/>
              </c:ext>
            </c:extLst>
          </c:dPt>
          <c:xVal>
            <c:numRef>
              <c:f>Appendix!$C$17:$C$29</c:f>
              <c:numCache>
                <c:formatCode>0.0_);[Red]\(0.0\)</c:formatCode>
                <c:ptCount val="13"/>
                <c:pt idx="0">
                  <c:v>4</c:v>
                </c:pt>
                <c:pt idx="1">
                  <c:v>2.6297872340425532</c:v>
                </c:pt>
                <c:pt idx="2">
                  <c:v>2.6297872340425532</c:v>
                </c:pt>
                <c:pt idx="3">
                  <c:v>6.0034207525655647</c:v>
                </c:pt>
                <c:pt idx="4">
                  <c:v>5.4673539518900345</c:v>
                </c:pt>
                <c:pt idx="5">
                  <c:v>2.9186155285313378</c:v>
                </c:pt>
                <c:pt idx="6">
                  <c:v>2.6422284955164397</c:v>
                </c:pt>
                <c:pt idx="7">
                  <c:v>2.6</c:v>
                </c:pt>
                <c:pt idx="8">
                  <c:v>2.6</c:v>
                </c:pt>
                <c:pt idx="9">
                  <c:v>3.4</c:v>
                </c:pt>
                <c:pt idx="10">
                  <c:v>3.8</c:v>
                </c:pt>
                <c:pt idx="11">
                  <c:v>4</c:v>
                </c:pt>
                <c:pt idx="12">
                  <c:v>4</c:v>
                </c:pt>
              </c:numCache>
            </c:numRef>
          </c:xVal>
          <c:yVal>
            <c:numRef>
              <c:f>Appendix!$D$17:$D$29</c:f>
              <c:numCache>
                <c:formatCode>0.00_);[Red]\(0.00\)</c:formatCode>
                <c:ptCount val="13"/>
                <c:pt idx="0">
                  <c:v>0.97530240000000001</c:v>
                </c:pt>
                <c:pt idx="1">
                  <c:v>0.38946666666666668</c:v>
                </c:pt>
                <c:pt idx="2">
                  <c:v>0.80066666666666664</c:v>
                </c:pt>
                <c:pt idx="3">
                  <c:v>0.28999999999999998</c:v>
                </c:pt>
                <c:pt idx="4">
                  <c:v>-0.2</c:v>
                </c:pt>
                <c:pt idx="5">
                  <c:v>0.56533999999999995</c:v>
                </c:pt>
                <c:pt idx="6">
                  <c:v>-0.2</c:v>
                </c:pt>
                <c:pt idx="7">
                  <c:v>0.20699999999999999</c:v>
                </c:pt>
                <c:pt idx="8">
                  <c:v>0.04</c:v>
                </c:pt>
                <c:pt idx="9">
                  <c:v>0.42</c:v>
                </c:pt>
                <c:pt idx="10">
                  <c:v>0.61</c:v>
                </c:pt>
                <c:pt idx="11">
                  <c:v>0.36</c:v>
                </c:pt>
                <c:pt idx="12">
                  <c:v>1.4704915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2E0-44A4-810F-34FFC074F9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42208367"/>
        <c:axId val="1542208847"/>
      </c:scatterChart>
      <c:valAx>
        <c:axId val="1542208367"/>
        <c:scaling>
          <c:orientation val="minMax"/>
        </c:scaling>
        <c:delete val="0"/>
        <c:axPos val="b"/>
        <c:numFmt formatCode="0_ 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42208847"/>
        <c:crosses val="autoZero"/>
        <c:crossBetween val="midCat"/>
      </c:valAx>
      <c:valAx>
        <c:axId val="1542208847"/>
        <c:scaling>
          <c:orientation val="minMax"/>
          <c:max val="1.6"/>
          <c:min val="-0.2"/>
        </c:scaling>
        <c:delete val="0"/>
        <c:axPos val="l"/>
        <c:numFmt formatCode="#,##0.0_);[Red]\(#,##0.0\)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42208367"/>
        <c:crossesAt val="0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0621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3022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6284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763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534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490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9596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8331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896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3183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719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EE702E9-BD78-4862-9901-F9B12D08128B}" type="datetimeFigureOut">
              <a:rPr kumimoji="1" lang="ja-JP" altLang="en-US" smtClean="0"/>
              <a:t>2026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91BC81-5C5E-4D30-8D65-7D84208B58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1042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67652C1F-893B-7C4D-3B6A-63690E293C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1193974"/>
              </p:ext>
            </p:extLst>
          </p:nvPr>
        </p:nvGraphicFramePr>
        <p:xfrm>
          <a:off x="559220" y="528991"/>
          <a:ext cx="6695524" cy="51387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D2F2559F-A133-CDBF-C494-BF3B09542022}"/>
              </a:ext>
            </a:extLst>
          </p:cNvPr>
          <p:cNvSpPr/>
          <p:nvPr/>
        </p:nvSpPr>
        <p:spPr>
          <a:xfrm>
            <a:off x="559220" y="5463729"/>
            <a:ext cx="377851" cy="2040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FB7E509-DDE3-4D8A-FDF8-C1DEA1AE80A7}"/>
              </a:ext>
            </a:extLst>
          </p:cNvPr>
          <p:cNvSpPr txBox="1"/>
          <p:nvPr/>
        </p:nvSpPr>
        <p:spPr>
          <a:xfrm>
            <a:off x="3212995" y="5452324"/>
            <a:ext cx="69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A [18]*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695C28A-84E9-D1A7-AC6A-3EB01B0441A2}"/>
              </a:ext>
            </a:extLst>
          </p:cNvPr>
          <p:cNvSpPr txBox="1"/>
          <p:nvPr/>
        </p:nvSpPr>
        <p:spPr>
          <a:xfrm>
            <a:off x="3212995" y="4776971"/>
            <a:ext cx="7840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lgium [20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2B7FC03-7FC4-F113-4910-04DC98857469}"/>
              </a:ext>
            </a:extLst>
          </p:cNvPr>
          <p:cNvSpPr txBox="1"/>
          <p:nvPr/>
        </p:nvSpPr>
        <p:spPr>
          <a:xfrm>
            <a:off x="3212995" y="4360610"/>
            <a:ext cx="69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A [19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9401466-994E-52F1-E057-B9DDF6E68F05}"/>
              </a:ext>
            </a:extLst>
          </p:cNvPr>
          <p:cNvSpPr txBox="1"/>
          <p:nvPr/>
        </p:nvSpPr>
        <p:spPr>
          <a:xfrm>
            <a:off x="3878013" y="3670730"/>
            <a:ext cx="69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land [20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7EDF370-4D50-8EC1-6122-846CBCBDE49A}"/>
              </a:ext>
            </a:extLst>
          </p:cNvPr>
          <p:cNvSpPr txBox="1"/>
          <p:nvPr/>
        </p:nvSpPr>
        <p:spPr>
          <a:xfrm>
            <a:off x="4400708" y="3980041"/>
            <a:ext cx="8665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therland [12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2E03D41-8712-8C6A-17D9-A4559F96F13B}"/>
              </a:ext>
            </a:extLst>
          </p:cNvPr>
          <p:cNvSpPr txBox="1"/>
          <p:nvPr/>
        </p:nvSpPr>
        <p:spPr>
          <a:xfrm>
            <a:off x="5694220" y="5463729"/>
            <a:ext cx="866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ada [16]*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F8AB8EE-D523-BBBF-8E27-18F74852132B}"/>
              </a:ext>
            </a:extLst>
          </p:cNvPr>
          <p:cNvSpPr txBox="1"/>
          <p:nvPr/>
        </p:nvSpPr>
        <p:spPr>
          <a:xfrm>
            <a:off x="6213763" y="4101618"/>
            <a:ext cx="69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rea [15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DFF4194-C525-E207-F1BD-2675206CCF31}"/>
              </a:ext>
            </a:extLst>
          </p:cNvPr>
          <p:cNvSpPr txBox="1"/>
          <p:nvPr/>
        </p:nvSpPr>
        <p:spPr>
          <a:xfrm>
            <a:off x="3212995" y="2779933"/>
            <a:ext cx="69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nce [14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39F9CAE-7CCB-4699-1BED-AE5B73A1A2D9}"/>
              </a:ext>
            </a:extLst>
          </p:cNvPr>
          <p:cNvSpPr txBox="1"/>
          <p:nvPr/>
        </p:nvSpPr>
        <p:spPr>
          <a:xfrm>
            <a:off x="4400708" y="2292314"/>
            <a:ext cx="69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pan [23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7FFC76D-0665-D9D2-B9F7-2B317BDE26EF}"/>
              </a:ext>
            </a:extLst>
          </p:cNvPr>
          <p:cNvSpPr txBox="1"/>
          <p:nvPr/>
        </p:nvSpPr>
        <p:spPr>
          <a:xfrm>
            <a:off x="3212994" y="3907345"/>
            <a:ext cx="69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nce [13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DF5B1A5-C51B-041C-2B65-2BD781E93218}"/>
              </a:ext>
            </a:extLst>
          </p:cNvPr>
          <p:cNvSpPr txBox="1"/>
          <p:nvPr/>
        </p:nvSpPr>
        <p:spPr>
          <a:xfrm>
            <a:off x="3463636" y="3362091"/>
            <a:ext cx="69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 [17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382B6C2-21FF-60D6-FA13-81520A7561B3}"/>
              </a:ext>
            </a:extLst>
          </p:cNvPr>
          <p:cNvSpPr txBox="1"/>
          <p:nvPr/>
        </p:nvSpPr>
        <p:spPr>
          <a:xfrm>
            <a:off x="4235714" y="3290833"/>
            <a:ext cx="8665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rtugal [20]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47B0941-E189-15CF-2458-4A18B05E933F}"/>
              </a:ext>
            </a:extLst>
          </p:cNvPr>
          <p:cNvSpPr txBox="1"/>
          <p:nvPr/>
        </p:nvSpPr>
        <p:spPr>
          <a:xfrm>
            <a:off x="4408267" y="903081"/>
            <a:ext cx="85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rent study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4570B01-4A5F-2D2C-1438-DE046306DA3E}"/>
              </a:ext>
            </a:extLst>
          </p:cNvPr>
          <p:cNvSpPr txBox="1"/>
          <p:nvPr/>
        </p:nvSpPr>
        <p:spPr>
          <a:xfrm>
            <a:off x="6729529" y="5198408"/>
            <a:ext cx="21990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 of  cost of HD/Cost of SD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A5AEBF7-ECD2-9442-143B-94910BBA95BC}"/>
              </a:ext>
            </a:extLst>
          </p:cNvPr>
          <p:cNvSpPr txBox="1"/>
          <p:nvPr/>
        </p:nvSpPr>
        <p:spPr>
          <a:xfrm rot="16200000">
            <a:off x="-644614" y="2146318"/>
            <a:ext cx="21990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 of  cost of  ICER/WTP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75ED68A-D4E2-458C-0B2D-9B5A3BAA28A2}"/>
              </a:ext>
            </a:extLst>
          </p:cNvPr>
          <p:cNvSpPr txBox="1"/>
          <p:nvPr/>
        </p:nvSpPr>
        <p:spPr>
          <a:xfrm>
            <a:off x="1217940" y="6607151"/>
            <a:ext cx="2660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Canada[16], USA [18]: reported cost-saving results.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C1BECFF9-41EC-4E5B-92BD-15135461B730}"/>
              </a:ext>
            </a:extLst>
          </p:cNvPr>
          <p:cNvCxnSpPr>
            <a:cxnSpLocks/>
          </p:cNvCxnSpPr>
          <p:nvPr/>
        </p:nvCxnSpPr>
        <p:spPr>
          <a:xfrm>
            <a:off x="937071" y="2314985"/>
            <a:ext cx="6098519" cy="0"/>
          </a:xfrm>
          <a:prstGeom prst="line">
            <a:avLst/>
          </a:prstGeom>
          <a:ln w="9525"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6201911-DC65-91EE-37E8-CB30E2AA8083}"/>
              </a:ext>
            </a:extLst>
          </p:cNvPr>
          <p:cNvSpPr txBox="1"/>
          <p:nvPr/>
        </p:nvSpPr>
        <p:spPr>
          <a:xfrm>
            <a:off x="5979494" y="2256988"/>
            <a:ext cx="9282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↓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ER&lt;WTP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6659858-8D0B-B3DF-6AA9-3CEE59CC4B38}"/>
              </a:ext>
            </a:extLst>
          </p:cNvPr>
          <p:cNvSpPr txBox="1"/>
          <p:nvPr/>
        </p:nvSpPr>
        <p:spPr>
          <a:xfrm>
            <a:off x="5973825" y="2090116"/>
            <a:ext cx="10013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↑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ER&gt;WTP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DF98830-52FF-37D9-A757-D1D54C627BA9}"/>
              </a:ext>
            </a:extLst>
          </p:cNvPr>
          <p:cNvSpPr txBox="1"/>
          <p:nvPr/>
        </p:nvSpPr>
        <p:spPr>
          <a:xfrm>
            <a:off x="434529" y="6205294"/>
            <a:ext cx="82749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 plot of the HD/SD cost ratio versus the ICER/WTP ratio based on base-case results from published cost-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effectiveness analyses, restricted to studies that did not include productivity losses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5024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0</TotalTime>
  <Words>125</Words>
  <Application>Microsoft Office PowerPoint</Application>
  <PresentationFormat>画面に合わせる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oshi</dc:creator>
  <cp:lastModifiedBy>Hoshi</cp:lastModifiedBy>
  <cp:revision>10</cp:revision>
  <cp:lastPrinted>2026-01-21T05:06:16Z</cp:lastPrinted>
  <dcterms:created xsi:type="dcterms:W3CDTF">2026-01-14T07:28:15Z</dcterms:created>
  <dcterms:modified xsi:type="dcterms:W3CDTF">2026-01-22T01:13:50Z</dcterms:modified>
</cp:coreProperties>
</file>